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BE199-BC24-46B0-8C2A-07485B8AEB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DD230-DBE8-4C79-832C-86CDA37792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4BC9A-5F9A-4999-B230-48A5D5EF64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7701C-CABC-43D8-B879-0533DCB14D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DCFD07-E769-4B2D-9B34-EA4D2E44E8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45057-C5B0-4FB8-B372-40201E06B7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9428A-E60A-4493-8118-B4EE62C460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DF3A8-A8AF-4822-A3B5-377D100E60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E9A00-FFFA-4F3F-8B05-8B7E5A704D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6D485-1D0B-4DD4-A870-6701816805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00EC7-3E55-41D1-97D0-2DC178FF9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F4F75-47E3-462A-8350-15BD4F0F44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D808BD-AFB4-4453-9184-B9A12F0DCFF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90720" y="333360"/>
            <a:ext cx="6894360" cy="4815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132000" y="404640"/>
            <a:ext cx="100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y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643280" y="404640"/>
            <a:ext cx="100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y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39640" y="5313600"/>
            <a:ext cx="820908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Supplemental Figure 1. 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A typical microarray hybridization and its dye-reversal images.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 Right image is labeled with Cy3 and left image is labeled with Cy5. Our whole-genome microarray was organized into 4 columns and 12 rows, and contained 22,987 70-mer oligonucleotides representing known and predicted genes in the silkworm genom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7T17:01:29Z</dcterms:created>
  <dc:creator>番茄花园</dc:creator>
  <dc:description/>
  <dc:language>en-US</dc:language>
  <cp:lastModifiedBy>chengdj</cp:lastModifiedBy>
  <dcterms:modified xsi:type="dcterms:W3CDTF">2007-06-12T18:59:26Z</dcterms:modified>
  <cp:revision>10</cp:revision>
  <dc:subject/>
  <dc:title>幻灯片 1</dc:title>
</cp:coreProperties>
</file>